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63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1" autoAdjust="0"/>
    <p:restoredTop sz="94660"/>
  </p:normalViewPr>
  <p:slideViewPr>
    <p:cSldViewPr snapToGrid="0">
      <p:cViewPr varScale="1">
        <p:scale>
          <a:sx n="78" d="100"/>
          <a:sy n="78" d="100"/>
        </p:scale>
        <p:origin x="234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994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739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484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046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540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34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955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647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519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215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667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9B090-89AE-4196-B7BF-2F2E8BB09DBB}" type="datetimeFigureOut">
              <a:rPr lang="en-US" smtClean="0"/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DF81C-0BC8-4D74-9FA7-5F12D800D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842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Data Sets for Figure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Double click on any figure for data sets and statistical analysis. Prism software and statistical analyses were used, except for PCR, which uses log10[RQ] ≥ +/- 2 as indicating statistical significance (see Methods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09929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2451698"/>
              </p:ext>
            </p:extLst>
          </p:nvPr>
        </p:nvGraphicFramePr>
        <p:xfrm>
          <a:off x="2597150" y="2146300"/>
          <a:ext cx="3948113" cy="2563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5" r:id="rId3" imgW="3948840" imgH="2563200" progId="Prism5.Document">
                  <p:embed/>
                </p:oleObj>
              </mc:Choice>
              <mc:Fallback>
                <p:oleObj name="Prism 5" r:id="rId3" imgW="3948840" imgH="25632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97150" y="2146300"/>
                        <a:ext cx="3948113" cy="2563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36192" y="1438656"/>
            <a:ext cx="1759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 Data se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52515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3618985"/>
              </p:ext>
            </p:extLst>
          </p:nvPr>
        </p:nvGraphicFramePr>
        <p:xfrm>
          <a:off x="369888" y="1404938"/>
          <a:ext cx="8404225" cy="4048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5" r:id="rId3" imgW="8403480" imgH="4047480" progId="Prism5.Document">
                  <p:embed/>
                </p:oleObj>
              </mc:Choice>
              <mc:Fallback>
                <p:oleObj name="Prism 5" r:id="rId3" imgW="8403480" imgH="40474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9888" y="1404938"/>
                        <a:ext cx="8404225" cy="4048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97408" y="755904"/>
            <a:ext cx="1977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3 A data set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11114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8219773"/>
              </p:ext>
            </p:extLst>
          </p:nvPr>
        </p:nvGraphicFramePr>
        <p:xfrm>
          <a:off x="2005013" y="1833563"/>
          <a:ext cx="5132387" cy="3190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4" name="Prism 5" r:id="rId3" imgW="5132880" imgH="3191040" progId="Prism5.Document">
                  <p:embed/>
                </p:oleObj>
              </mc:Choice>
              <mc:Fallback>
                <p:oleObj name="Prism 5" r:id="rId3" imgW="5132880" imgH="319104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05013" y="1833563"/>
                        <a:ext cx="5132387" cy="3190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97408" y="755904"/>
            <a:ext cx="24024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3 A data set GTT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57630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2954691"/>
              </p:ext>
            </p:extLst>
          </p:nvPr>
        </p:nvGraphicFramePr>
        <p:xfrm>
          <a:off x="642938" y="2082800"/>
          <a:ext cx="7859712" cy="2692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3" name="Prism 5" r:id="rId3" imgW="7859160" imgH="2692800" progId="Prism5.Document">
                  <p:embed/>
                </p:oleObj>
              </mc:Choice>
              <mc:Fallback>
                <p:oleObj name="Prism 5" r:id="rId3" imgW="7859160" imgH="26928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2938" y="2082800"/>
                        <a:ext cx="7859712" cy="2692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97408" y="755904"/>
            <a:ext cx="1977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3 B data set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043447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1405377"/>
              </p:ext>
            </p:extLst>
          </p:nvPr>
        </p:nvGraphicFramePr>
        <p:xfrm>
          <a:off x="1989138" y="1916113"/>
          <a:ext cx="5165725" cy="3025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8" name="Prism 5" r:id="rId3" imgW="5166360" imgH="3026520" progId="Prism5.Document">
                  <p:embed/>
                </p:oleObj>
              </mc:Choice>
              <mc:Fallback>
                <p:oleObj name="Prism 5" r:id="rId3" imgW="5166360" imgH="30265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89138" y="1916113"/>
                        <a:ext cx="5165725" cy="3025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97408" y="755904"/>
            <a:ext cx="2394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3 B data set GTT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4194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7321442"/>
              </p:ext>
            </p:extLst>
          </p:nvPr>
        </p:nvGraphicFramePr>
        <p:xfrm>
          <a:off x="2614613" y="2239963"/>
          <a:ext cx="3913187" cy="2378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0" name="Prism 5" r:id="rId3" imgW="3913560" imgH="2377440" progId="Prism5.Document">
                  <p:embed/>
                </p:oleObj>
              </mc:Choice>
              <mc:Fallback>
                <p:oleObj name="Prism 5" r:id="rId3" imgW="3913560" imgH="237744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14613" y="2239963"/>
                        <a:ext cx="3913187" cy="2378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97408" y="755904"/>
            <a:ext cx="1977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3 C data set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5191749"/>
      </p:ext>
    </p:extLst>
  </p:cSld>
  <p:clrMapOvr>
    <a:masterClrMapping/>
  </p:clrMapOvr>
</p:sld>
</file>

<file path=ppt/theme/theme1.xml><?xml version="1.0" encoding="utf-8"?>
<a:theme xmlns:a="http://schemas.openxmlformats.org/drawingml/2006/main" name="Normal siz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Normal size" id="{4852B7B5-51BA-448D-996B-C76B1B0F93F2}" vid="{93A14D14-85F1-427E-905C-66640BE24B71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25</TotalTime>
  <Words>74</Words>
  <Application>Microsoft Office PowerPoint</Application>
  <PresentationFormat>On-screen Show (4:3)</PresentationFormat>
  <Paragraphs>8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Normal size</vt:lpstr>
      <vt:lpstr>GraphPad Prism 5 Project</vt:lpstr>
      <vt:lpstr>Data Sets for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ata Sets for Plos</dc:title>
  <dc:creator>Anna Gooch</dc:creator>
  <cp:lastModifiedBy>Anna Gooch</cp:lastModifiedBy>
  <cp:revision>9</cp:revision>
  <dcterms:created xsi:type="dcterms:W3CDTF">2021-07-26T16:18:55Z</dcterms:created>
  <dcterms:modified xsi:type="dcterms:W3CDTF">2021-07-26T19:28:08Z</dcterms:modified>
</cp:coreProperties>
</file>